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427B9-8725-433C-8227-36ECB0A26F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8AC4E-884B-4501-BCAD-476C356313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444D2-E84D-48B3-B9E5-671BAC37A9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32FAB8-299F-45D9-94A8-6B28FD9C31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DF065-80A5-43BD-B5AA-C7487957B1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04040B-03FD-4DBC-BD03-D7E012F868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1D6FBF-293D-47A1-9DD9-7E08368DD6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84B1C-DE0C-4CF8-9A49-21F6C1534A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798A5-2F8F-4340-8D00-A19A676313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2F09A-34A6-4895-A2C0-37AC521428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C54657-B085-40F3-80E1-EA71CB7B82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62E79-4522-4BA0-8DBD-7827BD3A0C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58B747-06BB-465D-BDDE-8251628C1D8A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8000" y="765000"/>
          <a:ext cx="8929800" cy="4662720"/>
        </p:xfrm>
        <a:graphic>
          <a:graphicData uri="http://schemas.openxmlformats.org/drawingml/2006/table">
            <a:tbl>
              <a:tblPr/>
              <a:tblGrid>
                <a:gridCol w="1150920"/>
                <a:gridCol w="3168720"/>
                <a:gridCol w="3384360"/>
                <a:gridCol w="1225800"/>
              </a:tblGrid>
              <a:tr h="579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anscrip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prime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prime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cession no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hr1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CATGAGTTTCAGAGAC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GGGGCAGGATCAGAAGA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13102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lx1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GAGAGCGAGAGCGAGAG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GGTTGTTTCAGCAGTCC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131305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x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GCTGGACTCTTCTGGTC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TGTTCATTTGGGCAGTG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19814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xg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GAGTTGCCAGAGCAAGA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GTTGCTGACAGTGGAA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13106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fi1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CGGCCTACTCCAACCTA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TTCAGTCCGTGCTGTG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201338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r1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CTCTGCTCAGAGAAACAGC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CATGAGGAAAACTACACTA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Y576277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9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hx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CAGCAGCACCTATATGG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TGCTGTCCTCTGACCTG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001003980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9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6a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CACCAAACCGGAGAACA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TCGCTAGGGCTGACATAG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001009557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ox9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GTGGATTTGCAGGAATT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CAATGCATCATGATTTTT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131643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9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br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TACACAGGCTGCGACAT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TTGGAGCAGTTTTTCTC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M_001115090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611280" y="5660640"/>
            <a:ext cx="7920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79056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Additional data file 10.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nBank accession numbers and primer sequences used to clone partial cDNAs serving as ISH probe templates for genes chosen for validation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2T16:11:56Z</dcterms:created>
  <dc:creator>katharine.webb</dc:creator>
  <dc:description/>
  <dc:language>en-US</dc:language>
  <cp:lastModifiedBy>Laure Bally-Cuif</cp:lastModifiedBy>
  <dcterms:modified xsi:type="dcterms:W3CDTF">2009-07-02T06:55:56Z</dcterms:modified>
  <cp:revision>7</cp:revision>
  <dc:subject/>
  <dc:title>Folie 1</dc:title>
</cp:coreProperties>
</file>